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5" r:id="rId2"/>
    <p:sldId id="276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44" autoAdjust="0"/>
    <p:restoredTop sz="94660"/>
  </p:normalViewPr>
  <p:slideViewPr>
    <p:cSldViewPr snapToGrid="0">
      <p:cViewPr varScale="1">
        <p:scale>
          <a:sx n="44" d="100"/>
          <a:sy n="44" d="100"/>
        </p:scale>
        <p:origin x="2064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A5CEC6-3E53-464C-92B6-E4AEF41392B2}" type="datetimeFigureOut">
              <a:rPr kumimoji="1" lang="ja-JP" altLang="en-US" smtClean="0"/>
              <a:t>2024/11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3E43C-8043-4BBA-9440-60A9E1308C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5333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A5CEC6-3E53-464C-92B6-E4AEF41392B2}" type="datetimeFigureOut">
              <a:rPr kumimoji="1" lang="ja-JP" altLang="en-US" smtClean="0"/>
              <a:t>2024/11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3E43C-8043-4BBA-9440-60A9E1308C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79156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A5CEC6-3E53-464C-92B6-E4AEF41392B2}" type="datetimeFigureOut">
              <a:rPr kumimoji="1" lang="ja-JP" altLang="en-US" smtClean="0"/>
              <a:t>2024/11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3E43C-8043-4BBA-9440-60A9E1308C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83558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A5CEC6-3E53-464C-92B6-E4AEF41392B2}" type="datetimeFigureOut">
              <a:rPr kumimoji="1" lang="ja-JP" altLang="en-US" smtClean="0"/>
              <a:t>2024/11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3E43C-8043-4BBA-9440-60A9E1308C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36664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A5CEC6-3E53-464C-92B6-E4AEF41392B2}" type="datetimeFigureOut">
              <a:rPr kumimoji="1" lang="ja-JP" altLang="en-US" smtClean="0"/>
              <a:t>2024/11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3E43C-8043-4BBA-9440-60A9E1308C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52988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A5CEC6-3E53-464C-92B6-E4AEF41392B2}" type="datetimeFigureOut">
              <a:rPr kumimoji="1" lang="ja-JP" altLang="en-US" smtClean="0"/>
              <a:t>2024/11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3E43C-8043-4BBA-9440-60A9E1308C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71599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A5CEC6-3E53-464C-92B6-E4AEF41392B2}" type="datetimeFigureOut">
              <a:rPr kumimoji="1" lang="ja-JP" altLang="en-US" smtClean="0"/>
              <a:t>2024/11/2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3E43C-8043-4BBA-9440-60A9E1308C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10759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A5CEC6-3E53-464C-92B6-E4AEF41392B2}" type="datetimeFigureOut">
              <a:rPr kumimoji="1" lang="ja-JP" altLang="en-US" smtClean="0"/>
              <a:t>2024/11/2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3E43C-8043-4BBA-9440-60A9E1308C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17139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A5CEC6-3E53-464C-92B6-E4AEF41392B2}" type="datetimeFigureOut">
              <a:rPr kumimoji="1" lang="ja-JP" altLang="en-US" smtClean="0"/>
              <a:t>2024/11/2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3E43C-8043-4BBA-9440-60A9E1308C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59748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A5CEC6-3E53-464C-92B6-E4AEF41392B2}" type="datetimeFigureOut">
              <a:rPr kumimoji="1" lang="ja-JP" altLang="en-US" smtClean="0"/>
              <a:t>2024/11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3E43C-8043-4BBA-9440-60A9E1308C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246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A5CEC6-3E53-464C-92B6-E4AEF41392B2}" type="datetimeFigureOut">
              <a:rPr kumimoji="1" lang="ja-JP" altLang="en-US" smtClean="0"/>
              <a:t>2024/11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3E43C-8043-4BBA-9440-60A9E1308C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2295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A5CEC6-3E53-464C-92B6-E4AEF41392B2}" type="datetimeFigureOut">
              <a:rPr kumimoji="1" lang="ja-JP" altLang="en-US" smtClean="0"/>
              <a:t>2024/11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23E43C-8043-4BBA-9440-60A9E1308C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1916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9AE2478-E366-67B6-D10C-D73A72B84E3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F6A23D5B-2886-1FB1-073D-5F245383558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60786355"/>
              </p:ext>
            </p:extLst>
          </p:nvPr>
        </p:nvGraphicFramePr>
        <p:xfrm>
          <a:off x="1094759" y="1025757"/>
          <a:ext cx="4668482" cy="5955770"/>
        </p:xfrm>
        <a:graphic>
          <a:graphicData uri="http://schemas.openxmlformats.org/drawingml/2006/table">
            <a:tbl>
              <a:tblPr/>
              <a:tblGrid>
                <a:gridCol w="303866">
                  <a:extLst>
                    <a:ext uri="{9D8B030D-6E8A-4147-A177-3AD203B41FA5}">
                      <a16:colId xmlns:a16="http://schemas.microsoft.com/office/drawing/2014/main" val="386555262"/>
                    </a:ext>
                  </a:extLst>
                </a:gridCol>
                <a:gridCol w="727436">
                  <a:extLst>
                    <a:ext uri="{9D8B030D-6E8A-4147-A177-3AD203B41FA5}">
                      <a16:colId xmlns:a16="http://schemas.microsoft.com/office/drawing/2014/main" val="2428110512"/>
                    </a:ext>
                  </a:extLst>
                </a:gridCol>
                <a:gridCol w="1952106">
                  <a:extLst>
                    <a:ext uri="{9D8B030D-6E8A-4147-A177-3AD203B41FA5}">
                      <a16:colId xmlns:a16="http://schemas.microsoft.com/office/drawing/2014/main" val="1046921551"/>
                    </a:ext>
                  </a:extLst>
                </a:gridCol>
                <a:gridCol w="653772">
                  <a:extLst>
                    <a:ext uri="{9D8B030D-6E8A-4147-A177-3AD203B41FA5}">
                      <a16:colId xmlns:a16="http://schemas.microsoft.com/office/drawing/2014/main" val="4139417243"/>
                    </a:ext>
                  </a:extLst>
                </a:gridCol>
                <a:gridCol w="1031302">
                  <a:extLst>
                    <a:ext uri="{9D8B030D-6E8A-4147-A177-3AD203B41FA5}">
                      <a16:colId xmlns:a16="http://schemas.microsoft.com/office/drawing/2014/main" val="504446522"/>
                    </a:ext>
                  </a:extLst>
                </a:gridCol>
              </a:tblGrid>
              <a:tr h="171306">
                <a:tc gridSpan="5">
                  <a:txBody>
                    <a:bodyPr/>
                    <a:lstStyle/>
                    <a:p>
                      <a:pPr algn="l" fontAlgn="ctr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upplementary table 1. Regimens of preoperative chemotherapy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76219424"/>
                  </a:ext>
                </a:extLst>
              </a:tr>
              <a:tr h="160254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gimens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umber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ycle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59113591"/>
                  </a:ext>
                </a:extLst>
              </a:tr>
              <a:tr h="160254"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nversion surgery cases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23201734"/>
                  </a:ext>
                </a:extLst>
              </a:tr>
              <a:tr h="160254"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pe+CDDP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53914344"/>
                  </a:ext>
                </a:extLst>
              </a:tr>
              <a:tr h="160254"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pe+CDDP+T-mab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45695722"/>
                  </a:ext>
                </a:extLst>
              </a:tr>
              <a:tr h="160254"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pe+L-OHP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37545776"/>
                  </a:ext>
                </a:extLst>
              </a:tr>
              <a:tr h="160254"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pe+L-OHP+T-mab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98672183"/>
                  </a:ext>
                </a:extLst>
              </a:tr>
              <a:tr h="160254"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pe+L-OHP+T-mab→S1+T-mab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32768830"/>
                  </a:ext>
                </a:extLst>
              </a:tr>
              <a:tr h="160254"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pe+L-OHP+T-mab→S1+CDDP+T-mab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2049588"/>
                  </a:ext>
                </a:extLst>
              </a:tr>
              <a:tr h="160254"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pe+L-OHP→S1+CDDP→PTX+RAM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17286612"/>
                  </a:ext>
                </a:extLst>
              </a:tr>
              <a:tr h="160254"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TX+CDDP+S1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69018013"/>
                  </a:ext>
                </a:extLst>
              </a:tr>
              <a:tr h="160254"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TX+CDDP+S1+T-mab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9480418"/>
                  </a:ext>
                </a:extLst>
              </a:tr>
              <a:tr h="160254"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+CDDP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19513966"/>
                  </a:ext>
                </a:extLst>
              </a:tr>
              <a:tr h="160254"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+CDDP+PTXip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5335820"/>
                  </a:ext>
                </a:extLst>
              </a:tr>
              <a:tr h="160254"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+L-OHP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-9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61371348"/>
                  </a:ext>
                </a:extLst>
              </a:tr>
              <a:tr h="160254"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+L-OHP+T-mab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-8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35763504"/>
                  </a:ext>
                </a:extLst>
              </a:tr>
              <a:tr h="160254"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+L-OHP→PTX+RAM→Nivo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2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87959352"/>
                  </a:ext>
                </a:extLst>
              </a:tr>
              <a:tr h="331561"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t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+L-OHP＋T-mab→S1＋CDDP+T-mab</a:t>
                      </a:r>
                      <a:b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</a:b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→PTX+RAM→CPT11</a:t>
                      </a:r>
                    </a:p>
                  </a:txBody>
                  <a:tcPr marL="5526" marR="5526" marT="5526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3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65145897"/>
                  </a:ext>
                </a:extLst>
              </a:tr>
              <a:tr h="160254"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+PTXiv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9430229"/>
                  </a:ext>
                </a:extLst>
              </a:tr>
              <a:tr h="160254"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+PTXiv/ip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-15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8934675"/>
                  </a:ext>
                </a:extLst>
              </a:tr>
              <a:tr h="160254"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+PTXiv+T-mab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78495104"/>
                  </a:ext>
                </a:extLst>
              </a:tr>
              <a:tr h="160254"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-FU+L-OHP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11233909"/>
                  </a:ext>
                </a:extLst>
              </a:tr>
              <a:tr h="160254"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oadjuvant chemotherapy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80698812"/>
                  </a:ext>
                </a:extLst>
              </a:tr>
              <a:tr h="160254"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pe+L-OHP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-8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64255861"/>
                  </a:ext>
                </a:extLst>
              </a:tr>
              <a:tr h="160254"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TX+CDDP+S1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-4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67152475"/>
                  </a:ext>
                </a:extLst>
              </a:tr>
              <a:tr h="160254"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TX+L-OHP+S1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96093879"/>
                  </a:ext>
                </a:extLst>
              </a:tr>
              <a:tr h="160254"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+CDDP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03604524"/>
                  </a:ext>
                </a:extLst>
              </a:tr>
              <a:tr h="160254"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+CDDP→Cape+L-OHP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59170485"/>
                  </a:ext>
                </a:extLst>
              </a:tr>
              <a:tr h="160254"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+L-OHP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85758649"/>
                  </a:ext>
                </a:extLst>
              </a:tr>
              <a:tr h="160254"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+PTXiv/ip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84010576"/>
                  </a:ext>
                </a:extLst>
              </a:tr>
              <a:tr h="16025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-FU+L-OHP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-18</a:t>
                      </a:r>
                    </a:p>
                  </a:txBody>
                  <a:tcPr marL="5526" marR="5526" marT="55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62126244"/>
                  </a:ext>
                </a:extLst>
              </a:tr>
              <a:tr h="652069">
                <a:tc gridSpan="5">
                  <a:txBody>
                    <a:bodyPr/>
                    <a:lstStyle/>
                    <a:p>
                      <a:pPr algn="l" fontAlgn="t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pe: capecitabine, CDDP: cisplatin, DTX: docetaxel, </a:t>
                      </a:r>
                      <a:r>
                        <a:rPr lang="en-US" sz="105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p</a:t>
                      </a: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: intraperitoneal administration, iv: intravenous administration, L-OHP: oxaliplatin, </a:t>
                      </a:r>
                      <a:r>
                        <a:rPr lang="en-US" sz="105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ivo</a:t>
                      </a: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: nivolumab, PTX: paclitaxel, RAM: ramucirumab, T-mab: trastuzumab, 5-FU: fluorouracil.</a:t>
                      </a:r>
                    </a:p>
                  </a:txBody>
                  <a:tcPr marL="5526" marR="5526" marT="5526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2922637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262224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03F27A7-C2B6-E9C0-3D3F-096AF2F47C3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BDCD7BEF-621C-AD34-77C1-935951095F2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61864859"/>
              </p:ext>
            </p:extLst>
          </p:nvPr>
        </p:nvGraphicFramePr>
        <p:xfrm>
          <a:off x="1187450" y="1026319"/>
          <a:ext cx="4483100" cy="4603750"/>
        </p:xfrm>
        <a:graphic>
          <a:graphicData uri="http://schemas.openxmlformats.org/drawingml/2006/table">
            <a:tbl>
              <a:tblPr/>
              <a:tblGrid>
                <a:gridCol w="291799">
                  <a:extLst>
                    <a:ext uri="{9D8B030D-6E8A-4147-A177-3AD203B41FA5}">
                      <a16:colId xmlns:a16="http://schemas.microsoft.com/office/drawing/2014/main" val="3253476868"/>
                    </a:ext>
                  </a:extLst>
                </a:gridCol>
                <a:gridCol w="698550">
                  <a:extLst>
                    <a:ext uri="{9D8B030D-6E8A-4147-A177-3AD203B41FA5}">
                      <a16:colId xmlns:a16="http://schemas.microsoft.com/office/drawing/2014/main" val="1214304385"/>
                    </a:ext>
                  </a:extLst>
                </a:gridCol>
                <a:gridCol w="1874590">
                  <a:extLst>
                    <a:ext uri="{9D8B030D-6E8A-4147-A177-3AD203B41FA5}">
                      <a16:colId xmlns:a16="http://schemas.microsoft.com/office/drawing/2014/main" val="4196995905"/>
                    </a:ext>
                  </a:extLst>
                </a:gridCol>
                <a:gridCol w="627811">
                  <a:extLst>
                    <a:ext uri="{9D8B030D-6E8A-4147-A177-3AD203B41FA5}">
                      <a16:colId xmlns:a16="http://schemas.microsoft.com/office/drawing/2014/main" val="1326515006"/>
                    </a:ext>
                  </a:extLst>
                </a:gridCol>
                <a:gridCol w="990350">
                  <a:extLst>
                    <a:ext uri="{9D8B030D-6E8A-4147-A177-3AD203B41FA5}">
                      <a16:colId xmlns:a16="http://schemas.microsoft.com/office/drawing/2014/main" val="3603205319"/>
                    </a:ext>
                  </a:extLst>
                </a:gridCol>
              </a:tblGrid>
              <a:tr h="196850">
                <a:tc gridSpan="5">
                  <a:txBody>
                    <a:bodyPr/>
                    <a:lstStyle/>
                    <a:p>
                      <a:pPr algn="l" fontAlgn="ctr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upplementary table 2. Regimens of </a:t>
                      </a:r>
                      <a:r>
                        <a:rPr lang="en-US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djuvan</a:t>
                      </a:r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chemotherapy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80078447"/>
                  </a:ext>
                </a:extLst>
              </a:tr>
              <a:tr h="342900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gimens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umber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uration (mohths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86127193"/>
                  </a:ext>
                </a:extLst>
              </a:tr>
              <a:tr h="184150"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tients without preoperative chemotherapy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19545876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TX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8067485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-2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91993011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+CDDP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59532357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+DTX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-48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46397999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+L-OHP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-1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6693325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+PTXiv/ip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84845695"/>
                  </a:ext>
                </a:extLst>
              </a:tr>
              <a:tr h="184150"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tients with preoperative chemotherapy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89165068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pe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-8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94237108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pe→S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34425777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pe+L-OHP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1146018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TX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34626489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ivo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26287247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TXip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54264086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8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-2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9927010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+DTX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-6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99163529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+L-OHP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-1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26248538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+PTXiv/ip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-2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75648857"/>
                  </a:ext>
                </a:extLst>
              </a:tr>
              <a:tr h="749300">
                <a:tc gridSpan="5">
                  <a:txBody>
                    <a:bodyPr/>
                    <a:lstStyle/>
                    <a:p>
                      <a:pPr algn="l" fontAlgn="t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pe: capecitabine, CDDP: cisplatin, DTX: docetaxel, </a:t>
                      </a:r>
                      <a:r>
                        <a:rPr lang="en-US" sz="105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p</a:t>
                      </a: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: intraperitoneal administration, iv: intravenous administration, L-OHP: oxaliplatin, </a:t>
                      </a:r>
                      <a:r>
                        <a:rPr lang="en-US" sz="105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ivo</a:t>
                      </a: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: nivolumab, PTX: paclitaxel.</a:t>
                      </a:r>
                    </a:p>
                  </a:txBody>
                  <a:tcPr marL="6350" marR="6350" marT="6350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7935617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261846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9795</TotalTime>
  <Words>397</Words>
  <Application>Microsoft Office PowerPoint</Application>
  <PresentationFormat>画面に合わせる (4:3)</PresentationFormat>
  <Paragraphs>146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imonosono masataka</dc:creator>
  <cp:lastModifiedBy>masataka shimonosono</cp:lastModifiedBy>
  <cp:revision>42</cp:revision>
  <dcterms:created xsi:type="dcterms:W3CDTF">2023-04-15T13:09:52Z</dcterms:created>
  <dcterms:modified xsi:type="dcterms:W3CDTF">2024-11-25T13:21:52Z</dcterms:modified>
</cp:coreProperties>
</file>